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  <p:sldId id="257" r:id="rId6"/>
    <p:sldId id="26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Zhang, H. (Hong Zhang)" initials="ZH(Z" lastIdx="1" clrIdx="0">
    <p:extLst>
      <p:ext uri="{19B8F6BF-5375-455C-9EA6-DF929625EA0E}">
        <p15:presenceInfo xmlns:p15="http://schemas.microsoft.com/office/powerpoint/2012/main" userId="S-1-5-21-2169066342-2480738168-2466311071-21497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6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114" y="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193BF-6D74-4906-A274-561F2CAB65A0}" type="datetimeFigureOut">
              <a:rPr lang="en-US" smtClean="0"/>
              <a:t>8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98EDF-C6AD-4391-B5CE-29ABB1AD30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7817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193BF-6D74-4906-A274-561F2CAB65A0}" type="datetimeFigureOut">
              <a:rPr lang="en-US" smtClean="0"/>
              <a:t>8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98EDF-C6AD-4391-B5CE-29ABB1AD30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8886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193BF-6D74-4906-A274-561F2CAB65A0}" type="datetimeFigureOut">
              <a:rPr lang="en-US" smtClean="0"/>
              <a:t>8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98EDF-C6AD-4391-B5CE-29ABB1AD30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41969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193BF-6D74-4906-A274-561F2CAB65A0}" type="datetimeFigureOut">
              <a:rPr lang="en-US" smtClean="0"/>
              <a:t>8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98EDF-C6AD-4391-B5CE-29ABB1AD30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06353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193BF-6D74-4906-A274-561F2CAB65A0}" type="datetimeFigureOut">
              <a:rPr lang="en-US" smtClean="0"/>
              <a:t>8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98EDF-C6AD-4391-B5CE-29ABB1AD30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0730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193BF-6D74-4906-A274-561F2CAB65A0}" type="datetimeFigureOut">
              <a:rPr lang="en-US" smtClean="0"/>
              <a:t>8/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98EDF-C6AD-4391-B5CE-29ABB1AD30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7626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193BF-6D74-4906-A274-561F2CAB65A0}" type="datetimeFigureOut">
              <a:rPr lang="en-US" smtClean="0"/>
              <a:t>8/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98EDF-C6AD-4391-B5CE-29ABB1AD30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168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193BF-6D74-4906-A274-561F2CAB65A0}" type="datetimeFigureOut">
              <a:rPr lang="en-US" smtClean="0"/>
              <a:t>8/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98EDF-C6AD-4391-B5CE-29ABB1AD30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8413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193BF-6D74-4906-A274-561F2CAB65A0}" type="datetimeFigureOut">
              <a:rPr lang="en-US" smtClean="0"/>
              <a:t>8/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98EDF-C6AD-4391-B5CE-29ABB1AD30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71763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193BF-6D74-4906-A274-561F2CAB65A0}" type="datetimeFigureOut">
              <a:rPr lang="en-US" smtClean="0"/>
              <a:t>8/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98EDF-C6AD-4391-B5CE-29ABB1AD30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1707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193BF-6D74-4906-A274-561F2CAB65A0}" type="datetimeFigureOut">
              <a:rPr lang="en-US" smtClean="0"/>
              <a:t>8/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98EDF-C6AD-4391-B5CE-29ABB1AD30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1075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5193BF-6D74-4906-A274-561F2CAB65A0}" type="datetimeFigureOut">
              <a:rPr lang="en-US" smtClean="0"/>
              <a:t>8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F98EDF-C6AD-4391-B5CE-29ABB1AD30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848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tiff"/><Relationship Id="rId4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tiff"/><Relationship Id="rId4" Type="http://schemas.openxmlformats.org/officeDocument/2006/relationships/image" Target="../media/image10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tiff"/><Relationship Id="rId4" Type="http://schemas.openxmlformats.org/officeDocument/2006/relationships/image" Target="../media/image13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tiff"/><Relationship Id="rId5" Type="http://schemas.openxmlformats.org/officeDocument/2006/relationships/image" Target="../media/image17.tiff"/><Relationship Id="rId4" Type="http://schemas.openxmlformats.org/officeDocument/2006/relationships/image" Target="../media/image1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1132" y="1505173"/>
            <a:ext cx="4421124" cy="287426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9897" y="1817496"/>
            <a:ext cx="877900" cy="2249619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869896" y="717176"/>
            <a:ext cx="42399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1B:   NLRX1/Actin</a:t>
            </a:r>
          </a:p>
        </p:txBody>
      </p:sp>
    </p:spTree>
    <p:extLst>
      <p:ext uri="{BB962C8B-B14F-4D97-AF65-F5344CB8AC3E}">
        <p14:creationId xmlns:p14="http://schemas.microsoft.com/office/powerpoint/2010/main" val="2032793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3410" y="645587"/>
            <a:ext cx="877900" cy="2249619"/>
          </a:xfrm>
          <a:prstGeom prst="rect">
            <a:avLst/>
          </a:prstGeom>
        </p:spPr>
      </p:pic>
      <p:grpSp>
        <p:nvGrpSpPr>
          <p:cNvPr id="10" name="Group 9"/>
          <p:cNvGrpSpPr/>
          <p:nvPr/>
        </p:nvGrpSpPr>
        <p:grpSpPr>
          <a:xfrm>
            <a:off x="1159991" y="122832"/>
            <a:ext cx="4904232" cy="3144012"/>
            <a:chOff x="1159991" y="122832"/>
            <a:chExt cx="4904232" cy="3144012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59991" y="122832"/>
              <a:ext cx="4904232" cy="3144012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1341310" y="276255"/>
              <a:ext cx="10781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p-</a:t>
              </a:r>
              <a:r>
                <a:rPr lang="en-US" dirty="0" err="1"/>
                <a:t>Akt</a:t>
              </a:r>
              <a:endParaRPr lang="en-US" dirty="0"/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6765421" y="757004"/>
            <a:ext cx="4637532" cy="1999488"/>
            <a:chOff x="6765421" y="757004"/>
            <a:chExt cx="4637532" cy="1999488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65421" y="757004"/>
              <a:ext cx="4637532" cy="1999488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6946710" y="914400"/>
              <a:ext cx="9553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Akt</a:t>
              </a:r>
              <a:endParaRPr lang="en-US" dirty="0"/>
            </a:p>
          </p:txBody>
        </p:sp>
      </p:grpSp>
      <p:grpSp>
        <p:nvGrpSpPr>
          <p:cNvPr id="13" name="Group 12"/>
          <p:cNvGrpSpPr/>
          <p:nvPr/>
        </p:nvGrpSpPr>
        <p:grpSpPr>
          <a:xfrm>
            <a:off x="1426691" y="3788243"/>
            <a:ext cx="4637532" cy="2802636"/>
            <a:chOff x="1426691" y="3788243"/>
            <a:chExt cx="4637532" cy="2802636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26691" y="3788243"/>
              <a:ext cx="4637532" cy="2802636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1624084" y="3971499"/>
              <a:ext cx="10918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ctin</a:t>
              </a:r>
            </a:p>
          </p:txBody>
        </p:sp>
      </p:grpSp>
      <p:sp>
        <p:nvSpPr>
          <p:cNvPr id="14" name="TextBox 13"/>
          <p:cNvSpPr txBox="1"/>
          <p:nvPr/>
        </p:nvSpPr>
        <p:spPr>
          <a:xfrm>
            <a:off x="7110484" y="3971499"/>
            <a:ext cx="33164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4A: p-</a:t>
            </a:r>
            <a:r>
              <a:rPr lang="en-US" dirty="0" err="1"/>
              <a:t>Akt</a:t>
            </a:r>
            <a:r>
              <a:rPr lang="en-US" dirty="0"/>
              <a:t>/</a:t>
            </a:r>
            <a:r>
              <a:rPr lang="en-US" dirty="0" err="1"/>
              <a:t>Akt</a:t>
            </a:r>
            <a:r>
              <a:rPr lang="en-US" dirty="0"/>
              <a:t>/Actin</a:t>
            </a:r>
          </a:p>
        </p:txBody>
      </p:sp>
    </p:spTree>
    <p:extLst>
      <p:ext uri="{BB962C8B-B14F-4D97-AF65-F5344CB8AC3E}">
        <p14:creationId xmlns:p14="http://schemas.microsoft.com/office/powerpoint/2010/main" val="14769237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3410" y="536405"/>
            <a:ext cx="877900" cy="2249619"/>
          </a:xfrm>
          <a:prstGeom prst="rect">
            <a:avLst/>
          </a:prstGeom>
        </p:spPr>
      </p:pic>
      <p:grpSp>
        <p:nvGrpSpPr>
          <p:cNvPr id="7" name="Group 6"/>
          <p:cNvGrpSpPr/>
          <p:nvPr/>
        </p:nvGrpSpPr>
        <p:grpSpPr>
          <a:xfrm>
            <a:off x="1702774" y="369078"/>
            <a:ext cx="4637532" cy="2802636"/>
            <a:chOff x="1702774" y="369078"/>
            <a:chExt cx="4637532" cy="2802636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02774" y="369078"/>
              <a:ext cx="4637532" cy="2802636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69743" y="369078"/>
              <a:ext cx="9553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p-AMPK</a:t>
              </a: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6701770" y="369078"/>
            <a:ext cx="4637532" cy="2802636"/>
            <a:chOff x="6701770" y="369078"/>
            <a:chExt cx="4637532" cy="2802636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01770" y="369078"/>
              <a:ext cx="4637532" cy="2802636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6905766" y="369078"/>
              <a:ext cx="85980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MPK</a:t>
              </a:r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1702774" y="3447049"/>
            <a:ext cx="4637532" cy="2802636"/>
            <a:chOff x="1702774" y="3447049"/>
            <a:chExt cx="4637532" cy="2802636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02774" y="3447049"/>
              <a:ext cx="4637532" cy="2802636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1869743" y="3447049"/>
              <a:ext cx="955344" cy="3821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ctin</a:t>
              </a:r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7083188" y="3829186"/>
            <a:ext cx="4094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4C: p-AMPK/AMPK/Actin</a:t>
            </a:r>
          </a:p>
        </p:txBody>
      </p:sp>
    </p:spTree>
    <p:extLst>
      <p:ext uri="{BB962C8B-B14F-4D97-AF65-F5344CB8AC3E}">
        <p14:creationId xmlns:p14="http://schemas.microsoft.com/office/powerpoint/2010/main" val="24530285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3410" y="536405"/>
            <a:ext cx="877900" cy="224961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1310" y="4284260"/>
            <a:ext cx="4314444" cy="609600"/>
          </a:xfrm>
          <a:prstGeom prst="rect">
            <a:avLst/>
          </a:prstGeom>
        </p:spPr>
      </p:pic>
      <p:grpSp>
        <p:nvGrpSpPr>
          <p:cNvPr id="7" name="Group 6"/>
          <p:cNvGrpSpPr/>
          <p:nvPr/>
        </p:nvGrpSpPr>
        <p:grpSpPr>
          <a:xfrm>
            <a:off x="1341310" y="259896"/>
            <a:ext cx="4637532" cy="2802636"/>
            <a:chOff x="1341310" y="259896"/>
            <a:chExt cx="4637532" cy="2802636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41310" y="259896"/>
              <a:ext cx="4637532" cy="2802636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446663" y="259896"/>
              <a:ext cx="124194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p-STAT3</a:t>
              </a: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6856742" y="259896"/>
            <a:ext cx="4637532" cy="2692908"/>
            <a:chOff x="6856742" y="259896"/>
            <a:chExt cx="4637532" cy="2692908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56742" y="259896"/>
              <a:ext cx="4637532" cy="2692908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7014950" y="259896"/>
              <a:ext cx="8598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STAT3</a:t>
              </a:r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1446663" y="3821373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ctin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6564573" y="4006039"/>
            <a:ext cx="39851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4E: p-STAT3/STAT3/Actin</a:t>
            </a:r>
          </a:p>
        </p:txBody>
      </p:sp>
    </p:spTree>
    <p:extLst>
      <p:ext uri="{BB962C8B-B14F-4D97-AF65-F5344CB8AC3E}">
        <p14:creationId xmlns:p14="http://schemas.microsoft.com/office/powerpoint/2010/main" val="6863584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3410" y="577347"/>
            <a:ext cx="877900" cy="2249619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7301552" y="4026090"/>
            <a:ext cx="33846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6C: p-PDH/PDH/a-tubulin</a:t>
            </a:r>
          </a:p>
        </p:txBody>
      </p:sp>
      <p:grpSp>
        <p:nvGrpSpPr>
          <p:cNvPr id="9" name="Group 8"/>
          <p:cNvGrpSpPr/>
          <p:nvPr/>
        </p:nvGrpSpPr>
        <p:grpSpPr>
          <a:xfrm>
            <a:off x="1644819" y="244448"/>
            <a:ext cx="5032248" cy="3198876"/>
            <a:chOff x="1644819" y="244448"/>
            <a:chExt cx="5032248" cy="3198876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44819" y="244448"/>
              <a:ext cx="5032248" cy="3198876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1842448" y="368490"/>
              <a:ext cx="9962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p-PDH</a:t>
              </a:r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7022323" y="244448"/>
            <a:ext cx="5032248" cy="3198876"/>
            <a:chOff x="7022323" y="244448"/>
            <a:chExt cx="5032248" cy="3198876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22323" y="244448"/>
              <a:ext cx="5032248" cy="3198876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7246961" y="312688"/>
              <a:ext cx="80521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PDH</a:t>
              </a:r>
            </a:p>
          </p:txBody>
        </p:sp>
      </p:grpSp>
      <p:grpSp>
        <p:nvGrpSpPr>
          <p:cNvPr id="13" name="Group 12"/>
          <p:cNvGrpSpPr/>
          <p:nvPr/>
        </p:nvGrpSpPr>
        <p:grpSpPr>
          <a:xfrm>
            <a:off x="1644819" y="3659124"/>
            <a:ext cx="5032248" cy="3198876"/>
            <a:chOff x="1644819" y="3659124"/>
            <a:chExt cx="5032248" cy="3198876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44819" y="3659124"/>
              <a:ext cx="5032248" cy="3198876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1692324" y="3684891"/>
              <a:ext cx="105087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-tubuli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808843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7313" y="300838"/>
            <a:ext cx="877900" cy="2249619"/>
          </a:xfrm>
          <a:prstGeom prst="rect">
            <a:avLst/>
          </a:prstGeom>
        </p:spPr>
      </p:pic>
      <p:grpSp>
        <p:nvGrpSpPr>
          <p:cNvPr id="10" name="Group 9"/>
          <p:cNvGrpSpPr/>
          <p:nvPr/>
        </p:nvGrpSpPr>
        <p:grpSpPr>
          <a:xfrm>
            <a:off x="1341310" y="337414"/>
            <a:ext cx="4603595" cy="2729484"/>
            <a:chOff x="1341310" y="337414"/>
            <a:chExt cx="4603595" cy="2729484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41310" y="337414"/>
              <a:ext cx="4386072" cy="2729484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4761564" y="352099"/>
              <a:ext cx="11833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cytoHK</a:t>
              </a:r>
              <a:r>
                <a:rPr lang="en-US" dirty="0"/>
                <a:t> II</a:t>
              </a: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6162429" y="300838"/>
            <a:ext cx="4619724" cy="2766060"/>
            <a:chOff x="6162429" y="300838"/>
            <a:chExt cx="4619724" cy="2766060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62429" y="300838"/>
              <a:ext cx="4349496" cy="2766060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9670262" y="300838"/>
              <a:ext cx="111189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ctin</a:t>
              </a:r>
            </a:p>
          </p:txBody>
        </p:sp>
      </p:grpSp>
      <p:grpSp>
        <p:nvGrpSpPr>
          <p:cNvPr id="14" name="Group 13"/>
          <p:cNvGrpSpPr/>
          <p:nvPr/>
        </p:nvGrpSpPr>
        <p:grpSpPr>
          <a:xfrm>
            <a:off x="1341310" y="3893103"/>
            <a:ext cx="4098036" cy="2801112"/>
            <a:chOff x="1341310" y="3893103"/>
            <a:chExt cx="4098036" cy="2801112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41310" y="3893103"/>
              <a:ext cx="4098036" cy="2801112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4554071" y="3893103"/>
              <a:ext cx="88527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err="1"/>
                <a:t>mtHK</a:t>
              </a:r>
              <a:r>
                <a:rPr lang="en-US" dirty="0"/>
                <a:t> II</a:t>
              </a:r>
            </a:p>
          </p:txBody>
        </p:sp>
      </p:grpSp>
      <p:grpSp>
        <p:nvGrpSpPr>
          <p:cNvPr id="13" name="Group 12"/>
          <p:cNvGrpSpPr/>
          <p:nvPr/>
        </p:nvGrpSpPr>
        <p:grpSpPr>
          <a:xfrm>
            <a:off x="6162429" y="3893103"/>
            <a:ext cx="4349496" cy="2766060"/>
            <a:chOff x="6162429" y="3893103"/>
            <a:chExt cx="4349496" cy="2766060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62429" y="3893103"/>
              <a:ext cx="4349496" cy="2766060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9670262" y="3893103"/>
              <a:ext cx="84166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OX IV</a:t>
              </a:r>
            </a:p>
          </p:txBody>
        </p:sp>
      </p:grpSp>
      <p:sp>
        <p:nvSpPr>
          <p:cNvPr id="16" name="TextBox 15"/>
          <p:cNvSpPr txBox="1"/>
          <p:nvPr/>
        </p:nvSpPr>
        <p:spPr>
          <a:xfrm>
            <a:off x="4389310" y="3352800"/>
            <a:ext cx="2943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37408878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60</Words>
  <Application>Microsoft Office PowerPoint</Application>
  <PresentationFormat>Widescreen</PresentationFormat>
  <Paragraphs>22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A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, H. (Hong Zhang)</dc:creator>
  <cp:lastModifiedBy>Coert Zuurbier</cp:lastModifiedBy>
  <cp:revision>8</cp:revision>
  <dcterms:created xsi:type="dcterms:W3CDTF">2020-08-03T08:08:49Z</dcterms:created>
  <dcterms:modified xsi:type="dcterms:W3CDTF">2020-08-04T08:16:00Z</dcterms:modified>
</cp:coreProperties>
</file>